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69" r:id="rId2"/>
  </p:sldIdLst>
  <p:sldSz cx="6858000" cy="9906000" type="A4"/>
  <p:notesSz cx="6888163" cy="100187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40" autoAdjust="0"/>
    <p:restoredTop sz="94633"/>
  </p:normalViewPr>
  <p:slideViewPr>
    <p:cSldViewPr snapToGrid="0" snapToObjects="1">
      <p:cViewPr varScale="1">
        <p:scale>
          <a:sx n="80" d="100"/>
          <a:sy n="80" d="100"/>
        </p:scale>
        <p:origin x="299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hiro\Dropbox\SM\&#23455;&#39443;\2020\&#65303;\200720RNAseq_graph%20to%20validate%20realtimePCR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hiro\Dropbox\SM\&#23455;&#39443;\2020\&#65303;\200720RNAseq_graph%20to%20validate%20realtimePCR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hiro\Dropbox\SM\&#23455;&#39443;\2020\&#65303;\200720RNAseq_graph%20to%20validate%20realtimePCR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hiro\Dropbox\SM\&#23455;&#39443;\2020\&#65303;\200720RNAseq_graph%20to%20validate%20realtimePCR.xlsx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hiro\Dropbox\SM\&#23455;&#39443;\2020\&#65303;\200720RNAseq_graph%20to%20validate%20realtimePCR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hiro\Dropbox\SM\&#23455;&#39443;\2020\&#65303;\200720RNAseq_graph%20to%20validate%20realtimePCR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hiro\Dropbox\SM\&#23455;&#39443;\2020\&#65303;\200720RNAseq_graph%20to%20validate%20realtimePCR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hiro\Dropbox\SM\&#23455;&#39443;\2020\&#65303;\200720RNAseq_graph%20to%20validate%20realtimePCR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hiro\Dropbox\SM\&#23455;&#39443;\2020\&#65303;\200720RNAseq_graph%20to%20validate%20realtimePCR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hiro\Dropbox\SM\&#23455;&#39443;\2020\&#65303;\200720RNAseq_graph%20to%20validate%20realtimePCR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hiro\Dropbox\SM\&#23455;&#39443;\2020\&#65303;\200720RNAseq_graph%20to%20validate%20realtimePCR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hiro\Dropbox\SM\&#23455;&#39443;\2020\&#65303;\200720RNAseq_graph%20to%20validate%20realtimePCR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hiro\Dropbox\SM\&#23455;&#39443;\2020\&#65303;\200720RNAseq_graph%20to%20validate%20realtimePCR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i="1"/>
            </a:pPr>
            <a:r>
              <a:rPr lang="en-US" i="1"/>
              <a:t>OsHKT1;1</a:t>
            </a:r>
            <a:endParaRPr lang="ja-JP" i="1"/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log2じゃない方!$J$74:$K$74</c:f>
                <c:numCache>
                  <c:formatCode>General</c:formatCode>
                  <c:ptCount val="2"/>
                  <c:pt idx="0">
                    <c:v>5.3982215739627901E-2</c:v>
                  </c:pt>
                  <c:pt idx="1">
                    <c:v>7.1801546638272845E-2</c:v>
                  </c:pt>
                </c:numCache>
              </c:numRef>
            </c:plus>
            <c:minus>
              <c:numRef>
                <c:f>log2じゃない方!$J$74:$K$74</c:f>
                <c:numCache>
                  <c:formatCode>General</c:formatCode>
                  <c:ptCount val="2"/>
                  <c:pt idx="0">
                    <c:v>5.3982215739627901E-2</c:v>
                  </c:pt>
                  <c:pt idx="1">
                    <c:v>7.1801546638272845E-2</c:v>
                  </c:pt>
                </c:numCache>
              </c:numRef>
            </c:minus>
          </c:errBars>
          <c:val>
            <c:numRef>
              <c:f>log2じゃない方!$H$74:$I$74</c:f>
              <c:numCache>
                <c:formatCode>General</c:formatCode>
                <c:ptCount val="2"/>
                <c:pt idx="0">
                  <c:v>0.16156187508548703</c:v>
                </c:pt>
                <c:pt idx="1">
                  <c:v>0.1719211109942467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72A-4922-9272-F5D268AECD9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5786920"/>
        <c:axId val="575781016"/>
      </c:barChart>
      <c:catAx>
        <c:axId val="575786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1016"/>
        <c:crosses val="autoZero"/>
        <c:auto val="1"/>
        <c:lblAlgn val="ctr"/>
        <c:lblOffset val="100"/>
        <c:noMultiLvlLbl val="0"/>
      </c:catAx>
      <c:valAx>
        <c:axId val="57578101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9525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6920"/>
        <c:crosses val="autoZero"/>
        <c:crossBetween val="between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 sz="1000" b="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i="1"/>
            </a:pPr>
            <a:r>
              <a:rPr lang="en-US" i="1"/>
              <a:t>OsNHX4</a:t>
            </a:r>
            <a:endParaRPr lang="ja-JP" i="1"/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5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log2じゃない方!$J$79:$K$79</c:f>
                <c:numCache>
                  <c:formatCode>General</c:formatCode>
                  <c:ptCount val="2"/>
                  <c:pt idx="0">
                    <c:v>3.1364499505368618E-3</c:v>
                  </c:pt>
                  <c:pt idx="1">
                    <c:v>6.6736381725692826E-3</c:v>
                  </c:pt>
                </c:numCache>
              </c:numRef>
            </c:plus>
            <c:minus>
              <c:numRef>
                <c:f>log2じゃない方!$J$79:$K$79</c:f>
                <c:numCache>
                  <c:formatCode>General</c:formatCode>
                  <c:ptCount val="2"/>
                  <c:pt idx="0">
                    <c:v>3.1364499505368618E-3</c:v>
                  </c:pt>
                  <c:pt idx="1">
                    <c:v>6.6736381725692826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log2じゃない方!$H$84:$I$84</c:f>
              <c:numCache>
                <c:formatCode>General</c:formatCode>
                <c:ptCount val="2"/>
                <c:pt idx="0">
                  <c:v>1.61354681623142E-2</c:v>
                </c:pt>
                <c:pt idx="1">
                  <c:v>2.30193308153638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351-4361-B15A-0A1BC4CE06D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5786920"/>
        <c:axId val="575781016"/>
      </c:barChart>
      <c:catAx>
        <c:axId val="575786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1016"/>
        <c:crosses val="autoZero"/>
        <c:auto val="1"/>
        <c:lblAlgn val="ctr"/>
        <c:lblOffset val="100"/>
        <c:noMultiLvlLbl val="0"/>
      </c:catAx>
      <c:valAx>
        <c:axId val="57578101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9525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6920"/>
        <c:crosses val="autoZero"/>
        <c:crossBetween val="between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 sz="1000" b="0"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i="1"/>
            </a:pPr>
            <a:r>
              <a:rPr lang="en-US" i="1"/>
              <a:t>OsNHX2</a:t>
            </a:r>
            <a:endParaRPr lang="ja-JP" i="1"/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3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log2じゃない方!$J$82:$K$82</c:f>
                <c:numCache>
                  <c:formatCode>General</c:formatCode>
                  <c:ptCount val="2"/>
                  <c:pt idx="0">
                    <c:v>3.1960078631980138E-2</c:v>
                  </c:pt>
                  <c:pt idx="1">
                    <c:v>7.3088779181175567E-2</c:v>
                  </c:pt>
                </c:numCache>
              </c:numRef>
            </c:plus>
            <c:minus>
              <c:numRef>
                <c:f>log2じゃない方!$J$82:$K$82</c:f>
                <c:numCache>
                  <c:formatCode>General</c:formatCode>
                  <c:ptCount val="2"/>
                  <c:pt idx="0">
                    <c:v>3.1960078631980138E-2</c:v>
                  </c:pt>
                  <c:pt idx="1">
                    <c:v>7.308877918117556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log2じゃない方!$H$82:$I$82</c:f>
              <c:numCache>
                <c:formatCode>General</c:formatCode>
                <c:ptCount val="2"/>
                <c:pt idx="0">
                  <c:v>0.33013178289602768</c:v>
                </c:pt>
                <c:pt idx="1">
                  <c:v>0.29189702148631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50D-4E75-8416-2E08FA7F1F5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5786920"/>
        <c:axId val="575781016"/>
      </c:barChart>
      <c:catAx>
        <c:axId val="575786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1016"/>
        <c:crosses val="autoZero"/>
        <c:auto val="1"/>
        <c:lblAlgn val="ctr"/>
        <c:lblOffset val="100"/>
        <c:noMultiLvlLbl val="0"/>
      </c:catAx>
      <c:valAx>
        <c:axId val="57578101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9525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6920"/>
        <c:crosses val="autoZero"/>
        <c:crossBetween val="between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 sz="1000" b="0"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i="1"/>
            </a:pPr>
            <a:r>
              <a:rPr lang="en-US" i="1"/>
              <a:t>OsNHX5</a:t>
            </a:r>
            <a:endParaRPr lang="ja-JP" i="1"/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6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log2じゃない方!$J$85:$K$85</c:f>
                <c:numCache>
                  <c:formatCode>General</c:formatCode>
                  <c:ptCount val="2"/>
                  <c:pt idx="0">
                    <c:v>3.8941396760960485E-2</c:v>
                  </c:pt>
                  <c:pt idx="1">
                    <c:v>3.7194891205705988E-2</c:v>
                  </c:pt>
                </c:numCache>
              </c:numRef>
            </c:plus>
            <c:minus>
              <c:numRef>
                <c:f>log2じゃない方!$J$85:$K$85</c:f>
                <c:numCache>
                  <c:formatCode>General</c:formatCode>
                  <c:ptCount val="2"/>
                  <c:pt idx="0">
                    <c:v>3.8941396760960485E-2</c:v>
                  </c:pt>
                  <c:pt idx="1">
                    <c:v>3.719489120570598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log2じゃない方!$H$85:$I$85</c:f>
              <c:numCache>
                <c:formatCode>General</c:formatCode>
                <c:ptCount val="2"/>
                <c:pt idx="0">
                  <c:v>0.55679129050133369</c:v>
                </c:pt>
                <c:pt idx="1">
                  <c:v>0.601434395270155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AA8-4F0D-9A8C-1467425DB61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5786920"/>
        <c:axId val="575781016"/>
      </c:barChart>
      <c:catAx>
        <c:axId val="575786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1016"/>
        <c:crosses val="autoZero"/>
        <c:auto val="1"/>
        <c:lblAlgn val="ctr"/>
        <c:lblOffset val="100"/>
        <c:noMultiLvlLbl val="0"/>
      </c:catAx>
      <c:valAx>
        <c:axId val="57578101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9525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6920"/>
        <c:crosses val="autoZero"/>
        <c:crossBetween val="between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 sz="1000" b="0"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i="1"/>
            </a:pPr>
            <a:r>
              <a:rPr lang="en-US" i="1"/>
              <a:t>OsSOS1</a:t>
            </a:r>
            <a:endParaRPr lang="ja-JP" i="1"/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log2じゃない方!$J$86:$K$86</c:f>
                <c:numCache>
                  <c:formatCode>General</c:formatCode>
                  <c:ptCount val="2"/>
                  <c:pt idx="0">
                    <c:v>2.0091156009170257E-2</c:v>
                  </c:pt>
                  <c:pt idx="1">
                    <c:v>2.5277269754233972E-2</c:v>
                  </c:pt>
                </c:numCache>
              </c:numRef>
            </c:plus>
            <c:minus>
              <c:numRef>
                <c:f>log2じゃない方!$J$86:$K$86</c:f>
                <c:numCache>
                  <c:formatCode>General</c:formatCode>
                  <c:ptCount val="2"/>
                  <c:pt idx="0">
                    <c:v>2.0091156009170257E-2</c:v>
                  </c:pt>
                  <c:pt idx="1">
                    <c:v>2.527726975423397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log2じゃない方!$H$86:$I$86</c:f>
              <c:numCache>
                <c:formatCode>General</c:formatCode>
                <c:ptCount val="2"/>
                <c:pt idx="0">
                  <c:v>0.23927911761238194</c:v>
                </c:pt>
                <c:pt idx="1">
                  <c:v>0.203207019535350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160-4769-8FC0-471D4C8A9F5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5786920"/>
        <c:axId val="575781016"/>
      </c:barChart>
      <c:catAx>
        <c:axId val="575786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1016"/>
        <c:crosses val="autoZero"/>
        <c:auto val="1"/>
        <c:lblAlgn val="ctr"/>
        <c:lblOffset val="100"/>
        <c:noMultiLvlLbl val="0"/>
      </c:catAx>
      <c:valAx>
        <c:axId val="57578101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9525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6920"/>
        <c:crosses val="autoZero"/>
        <c:crossBetween val="between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 sz="1000" b="0"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i="1"/>
            </a:pPr>
            <a:r>
              <a:rPr lang="en-US" i="1"/>
              <a:t>OsHKT1;3</a:t>
            </a:r>
            <a:endParaRPr lang="ja-JP" i="1"/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2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log2じゃない方!$J$75:$K$75</c:f>
                <c:numCache>
                  <c:formatCode>General</c:formatCode>
                  <c:ptCount val="2"/>
                  <c:pt idx="0">
                    <c:v>4.2376216013130571E-3</c:v>
                  </c:pt>
                  <c:pt idx="1">
                    <c:v>9.1490161718667543E-2</c:v>
                  </c:pt>
                </c:numCache>
              </c:numRef>
            </c:plus>
            <c:minus>
              <c:numRef>
                <c:f>log2じゃない方!$J$75:$K$75</c:f>
                <c:numCache>
                  <c:formatCode>General</c:formatCode>
                  <c:ptCount val="2"/>
                  <c:pt idx="0">
                    <c:v>4.2376216013130571E-3</c:v>
                  </c:pt>
                  <c:pt idx="1">
                    <c:v>9.149016171866754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log2じゃない方!$H$75:$I$75</c:f>
              <c:numCache>
                <c:formatCode>General</c:formatCode>
                <c:ptCount val="2"/>
                <c:pt idx="0">
                  <c:v>2.8033658141241553E-2</c:v>
                </c:pt>
                <c:pt idx="1">
                  <c:v>0.320086621767413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B63-4039-9D78-35951D42B18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5786920"/>
        <c:axId val="575781016"/>
      </c:barChart>
      <c:catAx>
        <c:axId val="575786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1016"/>
        <c:crosses val="autoZero"/>
        <c:auto val="1"/>
        <c:lblAlgn val="ctr"/>
        <c:lblOffset val="100"/>
        <c:noMultiLvlLbl val="0"/>
      </c:catAx>
      <c:valAx>
        <c:axId val="57578101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9525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6920"/>
        <c:crosses val="autoZero"/>
        <c:crossBetween val="between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 sz="1000" b="0"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i="1"/>
            </a:pPr>
            <a:r>
              <a:rPr lang="en-US" i="1"/>
              <a:t>OsHKT1;4</a:t>
            </a:r>
            <a:endParaRPr lang="ja-JP" i="1"/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3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log2じゃない方!$J$76:$K$76</c:f>
                <c:numCache>
                  <c:formatCode>General</c:formatCode>
                  <c:ptCount val="2"/>
                  <c:pt idx="0">
                    <c:v>2.715195862973664E-3</c:v>
                  </c:pt>
                  <c:pt idx="1">
                    <c:v>1.9324754370226098E-3</c:v>
                  </c:pt>
                </c:numCache>
              </c:numRef>
            </c:plus>
            <c:minus>
              <c:numRef>
                <c:f>log2じゃない方!$J$76:$K$76</c:f>
                <c:numCache>
                  <c:formatCode>General</c:formatCode>
                  <c:ptCount val="2"/>
                  <c:pt idx="0">
                    <c:v>2.715195862973664E-3</c:v>
                  </c:pt>
                  <c:pt idx="1">
                    <c:v>1.9324754370226098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log2じゃない方!$H$76:$I$76</c:f>
              <c:numCache>
                <c:formatCode>General</c:formatCode>
                <c:ptCount val="2"/>
                <c:pt idx="0">
                  <c:v>3.4555129076484156E-2</c:v>
                </c:pt>
                <c:pt idx="1">
                  <c:v>1.431949156513866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A3C-4EA5-9F75-1EC9BFDD54F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5786920"/>
        <c:axId val="575781016"/>
      </c:barChart>
      <c:catAx>
        <c:axId val="575786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1016"/>
        <c:crosses val="autoZero"/>
        <c:auto val="1"/>
        <c:lblAlgn val="ctr"/>
        <c:lblOffset val="100"/>
        <c:noMultiLvlLbl val="0"/>
      </c:catAx>
      <c:valAx>
        <c:axId val="57578101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9525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6920"/>
        <c:crosses val="autoZero"/>
        <c:crossBetween val="between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 sz="1000" b="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i="1"/>
            </a:pPr>
            <a:r>
              <a:rPr lang="en-US" i="1"/>
              <a:t>OsHKT1;5</a:t>
            </a:r>
            <a:endParaRPr lang="ja-JP" i="1"/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4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log2じゃない方!$J$77:$K$77</c:f>
                <c:numCache>
                  <c:formatCode>General</c:formatCode>
                  <c:ptCount val="2"/>
                  <c:pt idx="0">
                    <c:v>4.0379256987001181E-3</c:v>
                  </c:pt>
                  <c:pt idx="1">
                    <c:v>1.5295835812024311E-2</c:v>
                  </c:pt>
                </c:numCache>
              </c:numRef>
            </c:plus>
            <c:minus>
              <c:numRef>
                <c:f>log2じゃない方!$J$77:$K$77</c:f>
                <c:numCache>
                  <c:formatCode>General</c:formatCode>
                  <c:ptCount val="2"/>
                  <c:pt idx="0">
                    <c:v>4.0379256987001181E-3</c:v>
                  </c:pt>
                  <c:pt idx="1">
                    <c:v>1.529583581202431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log2じゃない方!$H$77:$I$77</c:f>
              <c:numCache>
                <c:formatCode>General</c:formatCode>
                <c:ptCount val="2"/>
                <c:pt idx="0">
                  <c:v>2.7121929727955119E-2</c:v>
                </c:pt>
                <c:pt idx="1">
                  <c:v>9.627819155082073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FF0-4AEB-B269-5C69C4F9A9E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5786920"/>
        <c:axId val="575781016"/>
      </c:barChart>
      <c:catAx>
        <c:axId val="575786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1016"/>
        <c:crosses val="autoZero"/>
        <c:auto val="1"/>
        <c:lblAlgn val="ctr"/>
        <c:lblOffset val="100"/>
        <c:noMultiLvlLbl val="0"/>
      </c:catAx>
      <c:valAx>
        <c:axId val="57578101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9525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6920"/>
        <c:crosses val="autoZero"/>
        <c:crossBetween val="between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 sz="1000" b="0"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i="1"/>
            </a:pPr>
            <a:r>
              <a:rPr lang="en-US" i="1"/>
              <a:t>OsHKT2;1</a:t>
            </a:r>
            <a:endParaRPr lang="ja-JP" i="1"/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5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log2じゃない方!$J$78:$K$78</c:f>
                <c:numCache>
                  <c:formatCode>General</c:formatCode>
                  <c:ptCount val="2"/>
                  <c:pt idx="0">
                    <c:v>2.6804710172513003E-2</c:v>
                  </c:pt>
                  <c:pt idx="1">
                    <c:v>1.4157477696311606E-3</c:v>
                  </c:pt>
                </c:numCache>
              </c:numRef>
            </c:plus>
            <c:minus>
              <c:numRef>
                <c:f>log2じゃない方!$J$78:$K$78</c:f>
                <c:numCache>
                  <c:formatCode>General</c:formatCode>
                  <c:ptCount val="2"/>
                  <c:pt idx="0">
                    <c:v>2.6804710172513003E-2</c:v>
                  </c:pt>
                  <c:pt idx="1">
                    <c:v>1.4157477696311606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log2じゃない方!$H$78:$I$78</c:f>
              <c:numCache>
                <c:formatCode>General</c:formatCode>
                <c:ptCount val="2"/>
                <c:pt idx="0">
                  <c:v>9.7637377935248112E-2</c:v>
                </c:pt>
                <c:pt idx="1">
                  <c:v>1.651955577405906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20B-42EE-8E9E-9C315460CB6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5786920"/>
        <c:axId val="575781016"/>
      </c:barChart>
      <c:catAx>
        <c:axId val="575786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1016"/>
        <c:crosses val="autoZero"/>
        <c:auto val="1"/>
        <c:lblAlgn val="ctr"/>
        <c:lblOffset val="100"/>
        <c:noMultiLvlLbl val="0"/>
      </c:catAx>
      <c:valAx>
        <c:axId val="57578101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9525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6920"/>
        <c:crosses val="autoZero"/>
        <c:crossBetween val="between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 sz="1000" b="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i="1"/>
            </a:pPr>
            <a:r>
              <a:rPr lang="en-US" i="1"/>
              <a:t>OsHKT2;3</a:t>
            </a:r>
            <a:endParaRPr lang="ja-JP" i="1"/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log2じゃない方!$J$79:$K$79</c:f>
                <c:numCache>
                  <c:formatCode>General</c:formatCode>
                  <c:ptCount val="2"/>
                  <c:pt idx="0">
                    <c:v>3.1364499505368618E-3</c:v>
                  </c:pt>
                  <c:pt idx="1">
                    <c:v>6.6736381725692826E-3</c:v>
                  </c:pt>
                </c:numCache>
              </c:numRef>
            </c:plus>
            <c:minus>
              <c:numRef>
                <c:f>log2じゃない方!$J$79:$K$79</c:f>
                <c:numCache>
                  <c:formatCode>General</c:formatCode>
                  <c:ptCount val="2"/>
                  <c:pt idx="0">
                    <c:v>3.1364499505368618E-3</c:v>
                  </c:pt>
                  <c:pt idx="1">
                    <c:v>6.6736381725692826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log2じゃない方!$H$79:$I$79</c:f>
              <c:numCache>
                <c:formatCode>General</c:formatCode>
                <c:ptCount val="2"/>
                <c:pt idx="0">
                  <c:v>1.984091536696447E-2</c:v>
                </c:pt>
                <c:pt idx="1">
                  <c:v>0.12257032144572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178-482A-A014-859C7551E86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5786920"/>
        <c:axId val="575781016"/>
      </c:barChart>
      <c:catAx>
        <c:axId val="575786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1016"/>
        <c:crosses val="autoZero"/>
        <c:auto val="1"/>
        <c:lblAlgn val="ctr"/>
        <c:lblOffset val="100"/>
        <c:noMultiLvlLbl val="0"/>
      </c:catAx>
      <c:valAx>
        <c:axId val="57578101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9525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6920"/>
        <c:crosses val="autoZero"/>
        <c:crossBetween val="between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 sz="1000" b="0"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i="1"/>
            </a:pPr>
            <a:r>
              <a:rPr lang="en-US" i="1"/>
              <a:t>OsHKT2;4</a:t>
            </a:r>
            <a:endParaRPr lang="ja-JP" i="1"/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log2じゃない方!$J$80:$K$80</c:f>
                <c:numCache>
                  <c:formatCode>General</c:formatCode>
                  <c:ptCount val="2"/>
                  <c:pt idx="0">
                    <c:v>3.270220919119647E-3</c:v>
                  </c:pt>
                  <c:pt idx="1">
                    <c:v>1.7753249874382187E-2</c:v>
                  </c:pt>
                </c:numCache>
              </c:numRef>
            </c:plus>
            <c:minus>
              <c:numRef>
                <c:f>log2じゃない方!$J$80:$K$80</c:f>
                <c:numCache>
                  <c:formatCode>General</c:formatCode>
                  <c:ptCount val="2"/>
                  <c:pt idx="0">
                    <c:v>3.270220919119647E-3</c:v>
                  </c:pt>
                  <c:pt idx="1">
                    <c:v>1.775324987438218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log2じゃない方!$H$80:$I$80</c:f>
              <c:numCache>
                <c:formatCode>General</c:formatCode>
                <c:ptCount val="2"/>
                <c:pt idx="0">
                  <c:v>2.3433047060772524E-2</c:v>
                </c:pt>
                <c:pt idx="1">
                  <c:v>0.154345112195223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509-49DC-9897-B574A927415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5786920"/>
        <c:axId val="575781016"/>
      </c:barChart>
      <c:catAx>
        <c:axId val="575786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1016"/>
        <c:crosses val="autoZero"/>
        <c:auto val="1"/>
        <c:lblAlgn val="ctr"/>
        <c:lblOffset val="100"/>
        <c:noMultiLvlLbl val="0"/>
      </c:catAx>
      <c:valAx>
        <c:axId val="57578101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9525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6920"/>
        <c:crosses val="autoZero"/>
        <c:crossBetween val="between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 sz="1000" b="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i="1"/>
            </a:pPr>
            <a:r>
              <a:rPr lang="en-US" i="1"/>
              <a:t>OsNHX1</a:t>
            </a:r>
            <a:endParaRPr lang="ja-JP" i="1"/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2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log2じゃない方!$J$81:$K$81</c:f>
                <c:numCache>
                  <c:formatCode>General</c:formatCode>
                  <c:ptCount val="2"/>
                  <c:pt idx="0">
                    <c:v>0.47698090134188492</c:v>
                  </c:pt>
                  <c:pt idx="1">
                    <c:v>0.26672862967543459</c:v>
                  </c:pt>
                </c:numCache>
              </c:numRef>
            </c:plus>
            <c:minus>
              <c:numRef>
                <c:f>log2じゃない方!$J$81:$K$81</c:f>
                <c:numCache>
                  <c:formatCode>General</c:formatCode>
                  <c:ptCount val="2"/>
                  <c:pt idx="0">
                    <c:v>0.47698090134188492</c:v>
                  </c:pt>
                  <c:pt idx="1">
                    <c:v>0.2667286296754345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log2じゃない方!$H$81:$I$81</c:f>
              <c:numCache>
                <c:formatCode>General</c:formatCode>
                <c:ptCount val="2"/>
                <c:pt idx="0">
                  <c:v>1.8873397722294261</c:v>
                </c:pt>
                <c:pt idx="1">
                  <c:v>0.874371748387013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1E8-41F4-8ED5-0788F0ED038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5786920"/>
        <c:axId val="575781016"/>
      </c:barChart>
      <c:catAx>
        <c:axId val="575786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1016"/>
        <c:crosses val="autoZero"/>
        <c:auto val="1"/>
        <c:lblAlgn val="ctr"/>
        <c:lblOffset val="100"/>
        <c:noMultiLvlLbl val="0"/>
      </c:catAx>
      <c:valAx>
        <c:axId val="57578101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9525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6920"/>
        <c:crosses val="autoZero"/>
        <c:crossBetween val="between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 sz="1000" b="0"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 i="1"/>
            </a:pPr>
            <a:r>
              <a:rPr lang="en-US" i="1"/>
              <a:t>OsNHX3</a:t>
            </a:r>
            <a:endParaRPr lang="ja-JP" i="1"/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4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log2じゃない方!$J$83:$K$83</c:f>
                <c:numCache>
                  <c:formatCode>General</c:formatCode>
                  <c:ptCount val="2"/>
                  <c:pt idx="0">
                    <c:v>8.1704299138668335E-2</c:v>
                  </c:pt>
                  <c:pt idx="1">
                    <c:v>9.1786351018895554E-2</c:v>
                  </c:pt>
                </c:numCache>
              </c:numRef>
            </c:plus>
            <c:minus>
              <c:numRef>
                <c:f>log2じゃない方!$J$83:$K$83</c:f>
                <c:numCache>
                  <c:formatCode>General</c:formatCode>
                  <c:ptCount val="2"/>
                  <c:pt idx="0">
                    <c:v>8.1704299138668335E-2</c:v>
                  </c:pt>
                  <c:pt idx="1">
                    <c:v>9.178635101889555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log2じゃない方!$H$83:$I$83</c:f>
              <c:numCache>
                <c:formatCode>General</c:formatCode>
                <c:ptCount val="2"/>
                <c:pt idx="0">
                  <c:v>1.3369878226125447</c:v>
                </c:pt>
                <c:pt idx="1">
                  <c:v>0.724355343191795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1A7-49EF-87FD-77D94C94274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5786920"/>
        <c:axId val="575781016"/>
      </c:barChart>
      <c:catAx>
        <c:axId val="575786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1016"/>
        <c:crosses val="autoZero"/>
        <c:auto val="1"/>
        <c:lblAlgn val="ctr"/>
        <c:lblOffset val="100"/>
        <c:noMultiLvlLbl val="0"/>
      </c:catAx>
      <c:valAx>
        <c:axId val="57578101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 w="3175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575786920"/>
        <c:crosses val="autoZero"/>
        <c:crossBetween val="between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 sz="1000" b="0"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86" indent="0" algn="ctr">
              <a:buNone/>
              <a:defRPr sz="1500"/>
            </a:lvl2pPr>
            <a:lvl3pPr marL="685772" indent="0" algn="ctr">
              <a:buNone/>
              <a:defRPr sz="1350"/>
            </a:lvl3pPr>
            <a:lvl4pPr marL="1028657" indent="0" algn="ctr">
              <a:buNone/>
              <a:defRPr sz="1200"/>
            </a:lvl4pPr>
            <a:lvl5pPr marL="1371543" indent="0" algn="ctr">
              <a:buNone/>
              <a:defRPr sz="1200"/>
            </a:lvl5pPr>
            <a:lvl6pPr marL="1714428" indent="0" algn="ctr">
              <a:buNone/>
              <a:defRPr sz="1200"/>
            </a:lvl6pPr>
            <a:lvl7pPr marL="2057314" indent="0" algn="ctr">
              <a:buNone/>
              <a:defRPr sz="1200"/>
            </a:lvl7pPr>
            <a:lvl8pPr marL="2400199" indent="0" algn="ctr">
              <a:buNone/>
              <a:defRPr sz="1200"/>
            </a:lvl8pPr>
            <a:lvl9pPr marL="2743085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7998012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555463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9114313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2814285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86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72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6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4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2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19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08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957725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2235281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6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500" b="1"/>
            </a:lvl2pPr>
            <a:lvl3pPr marL="685772" indent="0">
              <a:buNone/>
              <a:defRPr sz="1350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199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500" b="1"/>
            </a:lvl2pPr>
            <a:lvl3pPr marL="685772" indent="0">
              <a:buNone/>
              <a:defRPr sz="1350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199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9495377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8650046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41637925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4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2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199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5373585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4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86" indent="0">
              <a:buNone/>
              <a:defRPr sz="2100"/>
            </a:lvl2pPr>
            <a:lvl3pPr marL="685772" indent="0">
              <a:buNone/>
              <a:defRPr sz="1800"/>
            </a:lvl3pPr>
            <a:lvl4pPr marL="1028657" indent="0">
              <a:buNone/>
              <a:defRPr sz="1500"/>
            </a:lvl4pPr>
            <a:lvl5pPr marL="1371543" indent="0">
              <a:buNone/>
              <a:defRPr sz="1500"/>
            </a:lvl5pPr>
            <a:lvl6pPr marL="1714428" indent="0">
              <a:buNone/>
              <a:defRPr sz="1500"/>
            </a:lvl6pPr>
            <a:lvl7pPr marL="2057314" indent="0">
              <a:buNone/>
              <a:defRPr sz="1500"/>
            </a:lvl7pPr>
            <a:lvl8pPr marL="2400199" indent="0">
              <a:buNone/>
              <a:defRPr sz="1500"/>
            </a:lvl8pPr>
            <a:lvl9pPr marL="2743085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2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199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6186762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6573739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772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3" indent="-171443" algn="l" defTabSz="685772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28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14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00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2985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871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757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643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28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86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72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57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43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28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314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199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085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13" Type="http://schemas.openxmlformats.org/officeDocument/2006/relationships/chart" Target="../charts/chart12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12" Type="http://schemas.openxmlformats.org/officeDocument/2006/relationships/chart" Target="../charts/chart11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Relationship Id="rId14" Type="http://schemas.openxmlformats.org/officeDocument/2006/relationships/chart" Target="../charts/char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47CC66F3-30EF-4CBE-8B47-C5B489865D0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19140001"/>
              </p:ext>
            </p:extLst>
          </p:nvPr>
        </p:nvGraphicFramePr>
        <p:xfrm>
          <a:off x="617829" y="692762"/>
          <a:ext cx="1938285" cy="14159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02C969E7-E3B3-411D-9B19-2AE67D30198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96675475"/>
              </p:ext>
            </p:extLst>
          </p:nvPr>
        </p:nvGraphicFramePr>
        <p:xfrm>
          <a:off x="2623238" y="692762"/>
          <a:ext cx="1938285" cy="14159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E2CF4BF2-EF9A-41FF-8401-84016DC45AF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54348352"/>
              </p:ext>
            </p:extLst>
          </p:nvPr>
        </p:nvGraphicFramePr>
        <p:xfrm>
          <a:off x="4612322" y="692762"/>
          <a:ext cx="1938285" cy="14159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80FC0A94-B33F-4416-9AEE-699F8F0BA1D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16709349"/>
              </p:ext>
            </p:extLst>
          </p:nvPr>
        </p:nvGraphicFramePr>
        <p:xfrm>
          <a:off x="617829" y="2161988"/>
          <a:ext cx="1938285" cy="141595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BD859F3C-64BE-4446-81A3-6C8A3872386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7511263"/>
              </p:ext>
            </p:extLst>
          </p:nvPr>
        </p:nvGraphicFramePr>
        <p:xfrm>
          <a:off x="2623238" y="2161989"/>
          <a:ext cx="1938285" cy="141595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id="{B835905B-2966-4273-B3C3-F478A87440B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09764486"/>
              </p:ext>
            </p:extLst>
          </p:nvPr>
        </p:nvGraphicFramePr>
        <p:xfrm>
          <a:off x="4612322" y="2161989"/>
          <a:ext cx="1938285" cy="141595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8" name="グラフ 7">
            <a:extLst>
              <a:ext uri="{FF2B5EF4-FFF2-40B4-BE49-F238E27FC236}">
                <a16:creationId xmlns:a16="http://schemas.microsoft.com/office/drawing/2014/main" id="{0CB776D6-47ED-4E3B-93B9-8CCF4AAC2BE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8157276"/>
              </p:ext>
            </p:extLst>
          </p:nvPr>
        </p:nvGraphicFramePr>
        <p:xfrm>
          <a:off x="617829" y="3648148"/>
          <a:ext cx="1938285" cy="14159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9" name="グラフ 8">
            <a:extLst>
              <a:ext uri="{FF2B5EF4-FFF2-40B4-BE49-F238E27FC236}">
                <a16:creationId xmlns:a16="http://schemas.microsoft.com/office/drawing/2014/main" id="{1658C676-00CD-4D75-B1EC-67D572581F6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73696675"/>
              </p:ext>
            </p:extLst>
          </p:nvPr>
        </p:nvGraphicFramePr>
        <p:xfrm>
          <a:off x="2623238" y="3651953"/>
          <a:ext cx="1938285" cy="14159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0" name="グラフ 9">
            <a:extLst>
              <a:ext uri="{FF2B5EF4-FFF2-40B4-BE49-F238E27FC236}">
                <a16:creationId xmlns:a16="http://schemas.microsoft.com/office/drawing/2014/main" id="{DD129C66-445E-4105-9753-DB658109FB1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30396418"/>
              </p:ext>
            </p:extLst>
          </p:nvPr>
        </p:nvGraphicFramePr>
        <p:xfrm>
          <a:off x="617829" y="5126931"/>
          <a:ext cx="1938285" cy="14159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11" name="グラフ 10">
            <a:extLst>
              <a:ext uri="{FF2B5EF4-FFF2-40B4-BE49-F238E27FC236}">
                <a16:creationId xmlns:a16="http://schemas.microsoft.com/office/drawing/2014/main" id="{DBA15D6C-9676-4A17-9C55-A34116CF015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89943259"/>
              </p:ext>
            </p:extLst>
          </p:nvPr>
        </p:nvGraphicFramePr>
        <p:xfrm>
          <a:off x="2623238" y="5126931"/>
          <a:ext cx="1938285" cy="14159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12" name="グラフ 11">
            <a:extLst>
              <a:ext uri="{FF2B5EF4-FFF2-40B4-BE49-F238E27FC236}">
                <a16:creationId xmlns:a16="http://schemas.microsoft.com/office/drawing/2014/main" id="{A7A3B23F-69C8-4D09-A8ED-2A2464B0E23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03925775"/>
              </p:ext>
            </p:extLst>
          </p:nvPr>
        </p:nvGraphicFramePr>
        <p:xfrm>
          <a:off x="4612322" y="3651952"/>
          <a:ext cx="1938285" cy="14159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13" name="グラフ 12">
            <a:extLst>
              <a:ext uri="{FF2B5EF4-FFF2-40B4-BE49-F238E27FC236}">
                <a16:creationId xmlns:a16="http://schemas.microsoft.com/office/drawing/2014/main" id="{9B12C628-9104-47CA-95CB-7246EDDA94A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05705087"/>
              </p:ext>
            </p:extLst>
          </p:nvPr>
        </p:nvGraphicFramePr>
        <p:xfrm>
          <a:off x="4619837" y="5126517"/>
          <a:ext cx="1938285" cy="14159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14" name="グラフ 13">
            <a:extLst>
              <a:ext uri="{FF2B5EF4-FFF2-40B4-BE49-F238E27FC236}">
                <a16:creationId xmlns:a16="http://schemas.microsoft.com/office/drawing/2014/main" id="{FBEBAFD1-D885-4B7D-A64A-8CF9CAE7189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56025890"/>
              </p:ext>
            </p:extLst>
          </p:nvPr>
        </p:nvGraphicFramePr>
        <p:xfrm>
          <a:off x="617221" y="6598564"/>
          <a:ext cx="1938285" cy="14159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13A3E40C-45AA-4754-AD43-3023AB9041CD}"/>
              </a:ext>
            </a:extLst>
          </p:cNvPr>
          <p:cNvSpPr txBox="1"/>
          <p:nvPr/>
        </p:nvSpPr>
        <p:spPr>
          <a:xfrm>
            <a:off x="3926998" y="1145517"/>
            <a:ext cx="263134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400" dirty="0"/>
              <a:t>*</a:t>
            </a:r>
            <a:endParaRPr kumimoji="1" lang="ja-JP" altLang="en-US" sz="1400" dirty="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60744EC6-DA91-497D-B314-FC676374A040}"/>
              </a:ext>
            </a:extLst>
          </p:cNvPr>
          <p:cNvSpPr txBox="1"/>
          <p:nvPr/>
        </p:nvSpPr>
        <p:spPr>
          <a:xfrm>
            <a:off x="5233806" y="983153"/>
            <a:ext cx="263134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400" dirty="0"/>
              <a:t>*</a:t>
            </a:r>
            <a:endParaRPr kumimoji="1" lang="ja-JP" altLang="en-US" sz="1400" dirty="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5D1529C0-4B4B-4066-AFE9-6066E9F4D17B}"/>
              </a:ext>
            </a:extLst>
          </p:cNvPr>
          <p:cNvSpPr txBox="1"/>
          <p:nvPr/>
        </p:nvSpPr>
        <p:spPr>
          <a:xfrm>
            <a:off x="1934148" y="2572442"/>
            <a:ext cx="263134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400" dirty="0"/>
              <a:t>*</a:t>
            </a:r>
            <a:endParaRPr kumimoji="1" lang="ja-JP" altLang="en-US" sz="1400" dirty="0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58E21E36-A12F-4868-9AD9-BA8B8523AD26}"/>
              </a:ext>
            </a:extLst>
          </p:cNvPr>
          <p:cNvSpPr txBox="1"/>
          <p:nvPr/>
        </p:nvSpPr>
        <p:spPr>
          <a:xfrm>
            <a:off x="3239792" y="2506598"/>
            <a:ext cx="263134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400" dirty="0"/>
              <a:t>*</a:t>
            </a:r>
            <a:endParaRPr kumimoji="1" lang="ja-JP" altLang="en-US" sz="1400" dirty="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EA297F5C-F489-4F2E-BC23-407A59F0B479}"/>
              </a:ext>
            </a:extLst>
          </p:cNvPr>
          <p:cNvSpPr txBox="1"/>
          <p:nvPr/>
        </p:nvSpPr>
        <p:spPr>
          <a:xfrm>
            <a:off x="5931718" y="2498433"/>
            <a:ext cx="263134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400" dirty="0"/>
              <a:t>*</a:t>
            </a:r>
            <a:endParaRPr kumimoji="1" lang="ja-JP" altLang="en-US" sz="1400" dirty="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A491F120-FBD2-4E6C-866B-C5DEB1820A28}"/>
              </a:ext>
            </a:extLst>
          </p:cNvPr>
          <p:cNvSpPr txBox="1"/>
          <p:nvPr/>
        </p:nvSpPr>
        <p:spPr>
          <a:xfrm>
            <a:off x="1935872" y="3972932"/>
            <a:ext cx="263134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400" dirty="0"/>
              <a:t>*</a:t>
            </a:r>
            <a:endParaRPr kumimoji="1" lang="ja-JP" altLang="en-US" sz="1400" dirty="0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FA406F2A-BC3E-4D8C-AD8F-BD5DD2654505}"/>
              </a:ext>
            </a:extLst>
          </p:cNvPr>
          <p:cNvSpPr txBox="1"/>
          <p:nvPr/>
        </p:nvSpPr>
        <p:spPr>
          <a:xfrm>
            <a:off x="1185095" y="5371219"/>
            <a:ext cx="263134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400" dirty="0"/>
              <a:t>*</a:t>
            </a:r>
            <a:endParaRPr kumimoji="1" lang="ja-JP" altLang="en-US" sz="1400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3E4377E-CB72-664A-B1A6-2BB6BE240D01}"/>
              </a:ext>
            </a:extLst>
          </p:cNvPr>
          <p:cNvSpPr txBox="1"/>
          <p:nvPr/>
        </p:nvSpPr>
        <p:spPr>
          <a:xfrm>
            <a:off x="617221" y="692763"/>
            <a:ext cx="277640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003F247F-D91D-3B4F-961A-8A23FE181679}"/>
              </a:ext>
            </a:extLst>
          </p:cNvPr>
          <p:cNvSpPr txBox="1"/>
          <p:nvPr/>
        </p:nvSpPr>
        <p:spPr>
          <a:xfrm>
            <a:off x="2623238" y="692762"/>
            <a:ext cx="269626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33A8F635-020C-D044-B25D-89B4494705CF}"/>
              </a:ext>
            </a:extLst>
          </p:cNvPr>
          <p:cNvSpPr txBox="1"/>
          <p:nvPr/>
        </p:nvSpPr>
        <p:spPr>
          <a:xfrm>
            <a:off x="4612322" y="692761"/>
            <a:ext cx="269626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73D74C22-D85D-0047-9322-DBA17AEE1CBE}"/>
              </a:ext>
            </a:extLst>
          </p:cNvPr>
          <p:cNvSpPr txBox="1"/>
          <p:nvPr/>
        </p:nvSpPr>
        <p:spPr>
          <a:xfrm>
            <a:off x="617221" y="2168823"/>
            <a:ext cx="277640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72F069CA-2DA5-6642-A4AE-CAF6159F699A}"/>
              </a:ext>
            </a:extLst>
          </p:cNvPr>
          <p:cNvSpPr txBox="1"/>
          <p:nvPr/>
        </p:nvSpPr>
        <p:spPr>
          <a:xfrm>
            <a:off x="2622739" y="2161988"/>
            <a:ext cx="263214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6BBE1FA2-A6BB-A449-A1EF-B789AD3F720F}"/>
              </a:ext>
            </a:extLst>
          </p:cNvPr>
          <p:cNvSpPr txBox="1"/>
          <p:nvPr/>
        </p:nvSpPr>
        <p:spPr>
          <a:xfrm>
            <a:off x="4625788" y="2167321"/>
            <a:ext cx="255198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05DB887A-0B29-1A47-9AF2-01FF90BE6EC2}"/>
              </a:ext>
            </a:extLst>
          </p:cNvPr>
          <p:cNvSpPr txBox="1"/>
          <p:nvPr/>
        </p:nvSpPr>
        <p:spPr>
          <a:xfrm>
            <a:off x="617221" y="3654616"/>
            <a:ext cx="277640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D55E24B8-5B31-EC4D-AF0B-0A7B8147E0E3}"/>
              </a:ext>
            </a:extLst>
          </p:cNvPr>
          <p:cNvSpPr txBox="1"/>
          <p:nvPr/>
        </p:nvSpPr>
        <p:spPr>
          <a:xfrm>
            <a:off x="2614602" y="3662152"/>
            <a:ext cx="277640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40B530F3-F924-E545-93E4-EB23A552D00B}"/>
              </a:ext>
            </a:extLst>
          </p:cNvPr>
          <p:cNvSpPr txBox="1"/>
          <p:nvPr/>
        </p:nvSpPr>
        <p:spPr>
          <a:xfrm>
            <a:off x="4625788" y="3662151"/>
            <a:ext cx="227948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F6B6BBF2-EB2D-124C-9CA8-5426B200DA16}"/>
              </a:ext>
            </a:extLst>
          </p:cNvPr>
          <p:cNvSpPr txBox="1"/>
          <p:nvPr/>
        </p:nvSpPr>
        <p:spPr>
          <a:xfrm>
            <a:off x="611716" y="5126590"/>
            <a:ext cx="234360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C97BFCB3-EA32-BD4A-89A2-05BD3692E379}"/>
              </a:ext>
            </a:extLst>
          </p:cNvPr>
          <p:cNvSpPr txBox="1"/>
          <p:nvPr/>
        </p:nvSpPr>
        <p:spPr>
          <a:xfrm>
            <a:off x="2624644" y="5126517"/>
            <a:ext cx="277640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37DA7F2C-6B2E-5448-8D58-0BB6179E8891}"/>
              </a:ext>
            </a:extLst>
          </p:cNvPr>
          <p:cNvSpPr txBox="1"/>
          <p:nvPr/>
        </p:nvSpPr>
        <p:spPr>
          <a:xfrm>
            <a:off x="4619837" y="5126516"/>
            <a:ext cx="263214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29318604-5D8E-7949-B5A6-06D89B62396F}"/>
              </a:ext>
            </a:extLst>
          </p:cNvPr>
          <p:cNvSpPr txBox="1"/>
          <p:nvPr/>
        </p:nvSpPr>
        <p:spPr>
          <a:xfrm>
            <a:off x="613356" y="6602650"/>
            <a:ext cx="298480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</p:txBody>
      </p:sp>
      <p:sp>
        <p:nvSpPr>
          <p:cNvPr id="51" name="テキスト ボックス 34">
            <a:extLst>
              <a:ext uri="{FF2B5EF4-FFF2-40B4-BE49-F238E27FC236}">
                <a16:creationId xmlns:a16="http://schemas.microsoft.com/office/drawing/2014/main" id="{C1E4A5D4-8B1F-BB44-9E1C-7D63A88AF8AD}"/>
              </a:ext>
            </a:extLst>
          </p:cNvPr>
          <p:cNvSpPr txBox="1"/>
          <p:nvPr/>
        </p:nvSpPr>
        <p:spPr>
          <a:xfrm>
            <a:off x="1071762" y="1817285"/>
            <a:ext cx="1400010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ntral        Peripher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テキスト ボックス 34">
            <a:extLst>
              <a:ext uri="{FF2B5EF4-FFF2-40B4-BE49-F238E27FC236}">
                <a16:creationId xmlns:a16="http://schemas.microsoft.com/office/drawing/2014/main" id="{F2EBA8E6-FB04-C64C-A505-46E1951A3A01}"/>
              </a:ext>
            </a:extLst>
          </p:cNvPr>
          <p:cNvSpPr txBox="1"/>
          <p:nvPr/>
        </p:nvSpPr>
        <p:spPr>
          <a:xfrm>
            <a:off x="3086123" y="1817285"/>
            <a:ext cx="1400010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ntral        Peripher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テキスト ボックス 34">
            <a:extLst>
              <a:ext uri="{FF2B5EF4-FFF2-40B4-BE49-F238E27FC236}">
                <a16:creationId xmlns:a16="http://schemas.microsoft.com/office/drawing/2014/main" id="{86EC1CD1-9DD2-F04B-84E5-660E49E5E94A}"/>
              </a:ext>
            </a:extLst>
          </p:cNvPr>
          <p:cNvSpPr txBox="1"/>
          <p:nvPr/>
        </p:nvSpPr>
        <p:spPr>
          <a:xfrm>
            <a:off x="5110346" y="1819326"/>
            <a:ext cx="1400010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ntral        Peripher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テキスト ボックス 34">
            <a:extLst>
              <a:ext uri="{FF2B5EF4-FFF2-40B4-BE49-F238E27FC236}">
                <a16:creationId xmlns:a16="http://schemas.microsoft.com/office/drawing/2014/main" id="{1F686785-35DE-6147-9B93-B250B6FE6CD8}"/>
              </a:ext>
            </a:extLst>
          </p:cNvPr>
          <p:cNvSpPr txBox="1"/>
          <p:nvPr/>
        </p:nvSpPr>
        <p:spPr>
          <a:xfrm>
            <a:off x="1071762" y="3289551"/>
            <a:ext cx="1400010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ntral        Peripher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テキスト ボックス 34">
            <a:extLst>
              <a:ext uri="{FF2B5EF4-FFF2-40B4-BE49-F238E27FC236}">
                <a16:creationId xmlns:a16="http://schemas.microsoft.com/office/drawing/2014/main" id="{8DE5BE24-67AB-D245-A863-5058020C17C5}"/>
              </a:ext>
            </a:extLst>
          </p:cNvPr>
          <p:cNvSpPr txBox="1"/>
          <p:nvPr/>
        </p:nvSpPr>
        <p:spPr>
          <a:xfrm>
            <a:off x="3086123" y="3289551"/>
            <a:ext cx="1400010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ntral        Peripher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テキスト ボックス 34">
            <a:extLst>
              <a:ext uri="{FF2B5EF4-FFF2-40B4-BE49-F238E27FC236}">
                <a16:creationId xmlns:a16="http://schemas.microsoft.com/office/drawing/2014/main" id="{AD4B8256-698B-4447-8B83-B46004B1D92C}"/>
              </a:ext>
            </a:extLst>
          </p:cNvPr>
          <p:cNvSpPr txBox="1"/>
          <p:nvPr/>
        </p:nvSpPr>
        <p:spPr>
          <a:xfrm>
            <a:off x="5110346" y="3291592"/>
            <a:ext cx="1400010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ntral        Peripher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テキスト ボックス 34">
            <a:extLst>
              <a:ext uri="{FF2B5EF4-FFF2-40B4-BE49-F238E27FC236}">
                <a16:creationId xmlns:a16="http://schemas.microsoft.com/office/drawing/2014/main" id="{C12CD6A7-823D-D540-BE30-8D8A75B8F7C4}"/>
              </a:ext>
            </a:extLst>
          </p:cNvPr>
          <p:cNvSpPr txBox="1"/>
          <p:nvPr/>
        </p:nvSpPr>
        <p:spPr>
          <a:xfrm>
            <a:off x="1071762" y="4774972"/>
            <a:ext cx="1400010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ntral        Peripher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テキスト ボックス 34">
            <a:extLst>
              <a:ext uri="{FF2B5EF4-FFF2-40B4-BE49-F238E27FC236}">
                <a16:creationId xmlns:a16="http://schemas.microsoft.com/office/drawing/2014/main" id="{12B094F9-B2A8-F94B-B1CF-1B666A22AAFC}"/>
              </a:ext>
            </a:extLst>
          </p:cNvPr>
          <p:cNvSpPr txBox="1"/>
          <p:nvPr/>
        </p:nvSpPr>
        <p:spPr>
          <a:xfrm>
            <a:off x="2967263" y="4774972"/>
            <a:ext cx="1400010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ntral        Peripher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テキスト ボックス 34">
            <a:extLst>
              <a:ext uri="{FF2B5EF4-FFF2-40B4-BE49-F238E27FC236}">
                <a16:creationId xmlns:a16="http://schemas.microsoft.com/office/drawing/2014/main" id="{87BC8963-5197-EF47-B059-B4B6677B957F}"/>
              </a:ext>
            </a:extLst>
          </p:cNvPr>
          <p:cNvSpPr txBox="1"/>
          <p:nvPr/>
        </p:nvSpPr>
        <p:spPr>
          <a:xfrm>
            <a:off x="5110346" y="4777013"/>
            <a:ext cx="1400010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ntral        Peripher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テキスト ボックス 34">
            <a:extLst>
              <a:ext uri="{FF2B5EF4-FFF2-40B4-BE49-F238E27FC236}">
                <a16:creationId xmlns:a16="http://schemas.microsoft.com/office/drawing/2014/main" id="{B1C18324-FBEC-D34A-BBD1-ED017BD397D0}"/>
              </a:ext>
            </a:extLst>
          </p:cNvPr>
          <p:cNvSpPr txBox="1"/>
          <p:nvPr/>
        </p:nvSpPr>
        <p:spPr>
          <a:xfrm>
            <a:off x="1071762" y="6247531"/>
            <a:ext cx="1400010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ntral        Peripher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テキスト ボックス 34">
            <a:extLst>
              <a:ext uri="{FF2B5EF4-FFF2-40B4-BE49-F238E27FC236}">
                <a16:creationId xmlns:a16="http://schemas.microsoft.com/office/drawing/2014/main" id="{9967EABC-3061-4842-924A-E99BD9A88FE0}"/>
              </a:ext>
            </a:extLst>
          </p:cNvPr>
          <p:cNvSpPr txBox="1"/>
          <p:nvPr/>
        </p:nvSpPr>
        <p:spPr>
          <a:xfrm>
            <a:off x="3086123" y="6247531"/>
            <a:ext cx="1400010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ntral        Peripher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テキスト ボックス 34">
            <a:extLst>
              <a:ext uri="{FF2B5EF4-FFF2-40B4-BE49-F238E27FC236}">
                <a16:creationId xmlns:a16="http://schemas.microsoft.com/office/drawing/2014/main" id="{EBD14747-C20C-BD4F-9C26-E0D82DDAA6D0}"/>
              </a:ext>
            </a:extLst>
          </p:cNvPr>
          <p:cNvSpPr txBox="1"/>
          <p:nvPr/>
        </p:nvSpPr>
        <p:spPr>
          <a:xfrm>
            <a:off x="5110346" y="6249572"/>
            <a:ext cx="1400010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ntral        Peripher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テキスト ボックス 34">
            <a:extLst>
              <a:ext uri="{FF2B5EF4-FFF2-40B4-BE49-F238E27FC236}">
                <a16:creationId xmlns:a16="http://schemas.microsoft.com/office/drawing/2014/main" id="{CF47B13B-0FF4-234D-9F93-0748522BBB5B}"/>
              </a:ext>
            </a:extLst>
          </p:cNvPr>
          <p:cNvSpPr txBox="1"/>
          <p:nvPr/>
        </p:nvSpPr>
        <p:spPr>
          <a:xfrm>
            <a:off x="1071762" y="7725479"/>
            <a:ext cx="140001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ntral        Peripher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Text Box 30">
            <a:extLst>
              <a:ext uri="{FF2B5EF4-FFF2-40B4-BE49-F238E27FC236}">
                <a16:creationId xmlns:a16="http://schemas.microsoft.com/office/drawing/2014/main" id="{400FB792-539C-AF42-B037-84812E8D9974}"/>
              </a:ext>
            </a:extLst>
          </p:cNvPr>
          <p:cNvSpPr txBox="1"/>
          <p:nvPr/>
        </p:nvSpPr>
        <p:spPr>
          <a:xfrm rot="16200000">
            <a:off x="-841297" y="4105867"/>
            <a:ext cx="2631440" cy="372379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132080" tIns="66040" rIns="132080" bIns="6604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JP" sz="1200" dirty="0">
                <a:latin typeface="Times New Roman" panose="02020603050405020304" pitchFamily="18" charset="0"/>
                <a:ea typeface="Yu Mincho" panose="02020400000000000000" pitchFamily="18" charset="-128"/>
                <a:cs typeface="Arial Unicode MS" panose="020B0604020202020204" pitchFamily="34" charset="-128"/>
              </a:rPr>
              <a:t>Relative expression level</a:t>
            </a:r>
            <a:endParaRPr lang="en-JP" sz="1400" dirty="0">
              <a:latin typeface="Calibri" panose="020F0502020204030204" pitchFamily="34" charset="0"/>
              <a:ea typeface="Yu Mincho" panose="02020400000000000000" pitchFamily="18" charset="-128"/>
              <a:cs typeface="Arial Unicode MS" panose="020B060402020202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8072858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910</TotalTime>
  <Words>62</Words>
  <Application>Microsoft Office PowerPoint</Application>
  <PresentationFormat>A4 210 x 297 mm</PresentationFormat>
  <Paragraphs>4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in Neang</dc:creator>
  <cp:lastModifiedBy>三屋 史朗</cp:lastModifiedBy>
  <cp:revision>90</cp:revision>
  <cp:lastPrinted>2020-08-12T07:18:28Z</cp:lastPrinted>
  <dcterms:created xsi:type="dcterms:W3CDTF">2020-05-19T13:06:08Z</dcterms:created>
  <dcterms:modified xsi:type="dcterms:W3CDTF">2020-08-13T07:26:24Z</dcterms:modified>
</cp:coreProperties>
</file>